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EA0E6"/>
    <a:srgbClr val="6EC5E3"/>
    <a:srgbClr val="A88A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08" y="24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Solomon_earlyreport_June19_anals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Solomon_earlyreport_June19_analsy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Solomon_earlyreport_June19_analsysi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stonebloom:Documents:Work:HPAEC%20data:Solomon_earlyreport_June19_anals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DTA_new#'!$N$51</c:f>
              <c:strCache>
                <c:ptCount val="1"/>
                <c:pt idx="0">
                  <c:v>Wild Type</c:v>
                </c:pt>
              </c:strCache>
            </c:strRef>
          </c:tx>
          <c:spPr>
            <a:solidFill>
              <a:srgbClr val="6EA0E6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TA_new#'!$I$53:$I$60</c:f>
                <c:numCache>
                  <c:formatCode>General</c:formatCode>
                  <c:ptCount val="8"/>
                  <c:pt idx="0">
                    <c:v>0.102505505338441</c:v>
                  </c:pt>
                  <c:pt idx="1">
                    <c:v>0.207190608663162</c:v>
                  </c:pt>
                  <c:pt idx="2">
                    <c:v>0.523883888938898</c:v>
                  </c:pt>
                  <c:pt idx="3">
                    <c:v>0.567899051174289</c:v>
                  </c:pt>
                  <c:pt idx="4">
                    <c:v>0.171556265759988</c:v>
                  </c:pt>
                  <c:pt idx="5">
                    <c:v>0.329482899486938</c:v>
                  </c:pt>
                  <c:pt idx="6">
                    <c:v>1.61251128405128</c:v>
                  </c:pt>
                  <c:pt idx="7">
                    <c:v>0.0564074673749597</c:v>
                  </c:pt>
                </c:numCache>
              </c:numRef>
            </c:plus>
            <c:minus>
              <c:numRef>
                <c:f>'CDTA_new#'!$I$53:$I$60</c:f>
                <c:numCache>
                  <c:formatCode>General</c:formatCode>
                  <c:ptCount val="8"/>
                  <c:pt idx="0">
                    <c:v>0.102505505338441</c:v>
                  </c:pt>
                  <c:pt idx="1">
                    <c:v>0.207190608663162</c:v>
                  </c:pt>
                  <c:pt idx="2">
                    <c:v>0.523883888938898</c:v>
                  </c:pt>
                  <c:pt idx="3">
                    <c:v>0.567899051174289</c:v>
                  </c:pt>
                  <c:pt idx="4">
                    <c:v>0.171556265759988</c:v>
                  </c:pt>
                  <c:pt idx="5">
                    <c:v>0.329482899486938</c:v>
                  </c:pt>
                  <c:pt idx="6">
                    <c:v>1.61251128405128</c:v>
                  </c:pt>
                  <c:pt idx="7">
                    <c:v>0.0564074673749597</c:v>
                  </c:pt>
                </c:numCache>
              </c:numRef>
            </c:minus>
          </c:errBars>
          <c:cat>
            <c:strRef>
              <c:f>'CDTA_new#'!$M$52:$M$59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CDTA_new#'!$N$52:$N$59</c:f>
              <c:numCache>
                <c:formatCode>General</c:formatCode>
                <c:ptCount val="8"/>
                <c:pt idx="0">
                  <c:v>1.333143066891851</c:v>
                </c:pt>
                <c:pt idx="1">
                  <c:v>7.592482315876564</c:v>
                </c:pt>
                <c:pt idx="2">
                  <c:v>15.23697162482329</c:v>
                </c:pt>
                <c:pt idx="3">
                  <c:v>12.32223973732002</c:v>
                </c:pt>
                <c:pt idx="4">
                  <c:v>1.15771823179891</c:v>
                </c:pt>
                <c:pt idx="5">
                  <c:v>4.646625647946055</c:v>
                </c:pt>
                <c:pt idx="6">
                  <c:v>56.90168249721189</c:v>
                </c:pt>
                <c:pt idx="7">
                  <c:v>0.809136878131405</c:v>
                </c:pt>
              </c:numCache>
            </c:numRef>
          </c:val>
        </c:ser>
        <c:ser>
          <c:idx val="3"/>
          <c:order val="1"/>
          <c:tx>
            <c:strRef>
              <c:f>'CDTA_new#'!$Q$51</c:f>
              <c:strCache>
                <c:ptCount val="1"/>
                <c:pt idx="0">
                  <c:v>35S::PAGR-6</c:v>
                </c:pt>
              </c:strCache>
            </c:strRef>
          </c:tx>
          <c:spPr>
            <a:solidFill>
              <a:srgbClr val="A88AD0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TA_new#'!$J$89:$J$96</c:f>
                <c:numCache>
                  <c:formatCode>General</c:formatCode>
                  <c:ptCount val="8"/>
                  <c:pt idx="0">
                    <c:v>0.15834862224273</c:v>
                  </c:pt>
                  <c:pt idx="1">
                    <c:v>0.339547795576477</c:v>
                  </c:pt>
                  <c:pt idx="2">
                    <c:v>0.945604782844797</c:v>
                  </c:pt>
                  <c:pt idx="3">
                    <c:v>0.524521740698956</c:v>
                  </c:pt>
                  <c:pt idx="4">
                    <c:v>0.398034197437026</c:v>
                  </c:pt>
                  <c:pt idx="5">
                    <c:v>0.397505840152044</c:v>
                  </c:pt>
                  <c:pt idx="6">
                    <c:v>1.62073257007866</c:v>
                  </c:pt>
                  <c:pt idx="7">
                    <c:v>0.0510373632092939</c:v>
                  </c:pt>
                </c:numCache>
              </c:numRef>
            </c:plus>
            <c:minus>
              <c:numRef>
                <c:f>'CDTA_new#'!$J$89:$J$96</c:f>
                <c:numCache>
                  <c:formatCode>General</c:formatCode>
                  <c:ptCount val="8"/>
                  <c:pt idx="0">
                    <c:v>0.15834862224273</c:v>
                  </c:pt>
                  <c:pt idx="1">
                    <c:v>0.339547795576477</c:v>
                  </c:pt>
                  <c:pt idx="2">
                    <c:v>0.945604782844797</c:v>
                  </c:pt>
                  <c:pt idx="3">
                    <c:v>0.524521740698956</c:v>
                  </c:pt>
                  <c:pt idx="4">
                    <c:v>0.398034197437026</c:v>
                  </c:pt>
                  <c:pt idx="5">
                    <c:v>0.397505840152044</c:v>
                  </c:pt>
                  <c:pt idx="6">
                    <c:v>1.62073257007866</c:v>
                  </c:pt>
                  <c:pt idx="7">
                    <c:v>0.0510373632092939</c:v>
                  </c:pt>
                </c:numCache>
              </c:numRef>
            </c:minus>
          </c:errBars>
          <c:cat>
            <c:strRef>
              <c:f>'CDTA_new#'!$M$52:$M$59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CDTA_new#'!$Q$52:$Q$59</c:f>
              <c:numCache>
                <c:formatCode>General</c:formatCode>
                <c:ptCount val="8"/>
                <c:pt idx="0">
                  <c:v>0.979128771336632</c:v>
                </c:pt>
                <c:pt idx="1">
                  <c:v>8.237466241873413</c:v>
                </c:pt>
                <c:pt idx="2">
                  <c:v>18.72607541065856</c:v>
                </c:pt>
                <c:pt idx="3">
                  <c:v>12.73244860444555</c:v>
                </c:pt>
                <c:pt idx="4">
                  <c:v>1.752575224913544</c:v>
                </c:pt>
                <c:pt idx="5">
                  <c:v>4.414876953246431</c:v>
                </c:pt>
                <c:pt idx="6">
                  <c:v>52.52260768032967</c:v>
                </c:pt>
                <c:pt idx="7">
                  <c:v>0.634821113196182</c:v>
                </c:pt>
              </c:numCache>
            </c:numRef>
          </c:val>
        </c:ser>
        <c:ser>
          <c:idx val="4"/>
          <c:order val="2"/>
          <c:tx>
            <c:strRef>
              <c:f>'CDTA_new#'!$R$51</c:f>
              <c:strCache>
                <c:ptCount val="1"/>
                <c:pt idx="0">
                  <c:v>35S::PAGR-7</c:v>
                </c:pt>
              </c:strCache>
            </c:strRef>
          </c:tx>
          <c:spPr>
            <a:solidFill>
              <a:srgbClr val="6EC5E3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TA_new#'!$J$101:$J$108</c:f>
                <c:numCache>
                  <c:formatCode>General</c:formatCode>
                  <c:ptCount val="8"/>
                  <c:pt idx="0">
                    <c:v>0.197197405976224</c:v>
                  </c:pt>
                  <c:pt idx="1">
                    <c:v>0.422681990232352</c:v>
                  </c:pt>
                  <c:pt idx="2">
                    <c:v>0.237390780876195</c:v>
                  </c:pt>
                  <c:pt idx="3">
                    <c:v>0.235499267464509</c:v>
                  </c:pt>
                  <c:pt idx="4">
                    <c:v>0.44810191051603</c:v>
                  </c:pt>
                  <c:pt idx="5">
                    <c:v>0.583411426424554</c:v>
                  </c:pt>
                  <c:pt idx="6">
                    <c:v>0.894332056816693</c:v>
                  </c:pt>
                  <c:pt idx="7">
                    <c:v>0.0885747148675825</c:v>
                  </c:pt>
                </c:numCache>
              </c:numRef>
            </c:plus>
            <c:minus>
              <c:numRef>
                <c:f>'CDTA_new#'!$J$101:$J$108</c:f>
                <c:numCache>
                  <c:formatCode>General</c:formatCode>
                  <c:ptCount val="8"/>
                  <c:pt idx="0">
                    <c:v>0.197197405976224</c:v>
                  </c:pt>
                  <c:pt idx="1">
                    <c:v>0.422681990232352</c:v>
                  </c:pt>
                  <c:pt idx="2">
                    <c:v>0.237390780876195</c:v>
                  </c:pt>
                  <c:pt idx="3">
                    <c:v>0.235499267464509</c:v>
                  </c:pt>
                  <c:pt idx="4">
                    <c:v>0.44810191051603</c:v>
                  </c:pt>
                  <c:pt idx="5">
                    <c:v>0.583411426424554</c:v>
                  </c:pt>
                  <c:pt idx="6">
                    <c:v>0.894332056816693</c:v>
                  </c:pt>
                  <c:pt idx="7">
                    <c:v>0.0885747148675825</c:v>
                  </c:pt>
                </c:numCache>
              </c:numRef>
            </c:minus>
          </c:errBars>
          <c:cat>
            <c:strRef>
              <c:f>'CDTA_new#'!$M$52:$M$59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CDTA_new#'!$R$52:$R$59</c:f>
              <c:numCache>
                <c:formatCode>General</c:formatCode>
                <c:ptCount val="8"/>
                <c:pt idx="0">
                  <c:v>1.110666370970901</c:v>
                </c:pt>
                <c:pt idx="1">
                  <c:v>8.123969419300725</c:v>
                </c:pt>
                <c:pt idx="2">
                  <c:v>17.48860586727456</c:v>
                </c:pt>
                <c:pt idx="3">
                  <c:v>12.5122456782711</c:v>
                </c:pt>
                <c:pt idx="4">
                  <c:v>1.682346850908058</c:v>
                </c:pt>
                <c:pt idx="5">
                  <c:v>4.390739621264172</c:v>
                </c:pt>
                <c:pt idx="6">
                  <c:v>53.96278411778732</c:v>
                </c:pt>
                <c:pt idx="7">
                  <c:v>0.7286420742231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610536"/>
        <c:axId val="2092613592"/>
      </c:barChart>
      <c:catAx>
        <c:axId val="2092610536"/>
        <c:scaling>
          <c:orientation val="minMax"/>
        </c:scaling>
        <c:delete val="0"/>
        <c:axPos val="b"/>
        <c:majorTickMark val="out"/>
        <c:minorTickMark val="none"/>
        <c:tickLblPos val="nextTo"/>
        <c:crossAx val="2092613592"/>
        <c:crosses val="autoZero"/>
        <c:auto val="1"/>
        <c:lblAlgn val="ctr"/>
        <c:lblOffset val="100"/>
        <c:noMultiLvlLbl val="0"/>
      </c:catAx>
      <c:valAx>
        <c:axId val="2092613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2610536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02127664462947"/>
          <c:y val="0.0952406481104755"/>
          <c:w val="0.414668270632838"/>
          <c:h val="0.244169159706101"/>
        </c:manualLayout>
      </c:layout>
      <c:overlay val="1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ew Sodium Carbonate'!$M$25</c:f>
              <c:strCache>
                <c:ptCount val="1"/>
                <c:pt idx="0">
                  <c:v>Wild Type</c:v>
                </c:pt>
              </c:strCache>
            </c:strRef>
          </c:tx>
          <c:spPr>
            <a:solidFill>
              <a:srgbClr val="6EA0E6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ew Sodium Carbonate'!$M$38:$M$45</c:f>
                <c:numCache>
                  <c:formatCode>General</c:formatCode>
                  <c:ptCount val="8"/>
                  <c:pt idx="0">
                    <c:v>0.108353706675674</c:v>
                  </c:pt>
                  <c:pt idx="1">
                    <c:v>1.12754324528945</c:v>
                  </c:pt>
                  <c:pt idx="2">
                    <c:v>0.471704228921582</c:v>
                  </c:pt>
                  <c:pt idx="3">
                    <c:v>1.084451191018042</c:v>
                  </c:pt>
                  <c:pt idx="4">
                    <c:v>0.371922355385587</c:v>
                  </c:pt>
                  <c:pt idx="5">
                    <c:v>1.77802393642285</c:v>
                  </c:pt>
                  <c:pt idx="6">
                    <c:v>1.00485146279031</c:v>
                  </c:pt>
                  <c:pt idx="7">
                    <c:v>0.246005188304451</c:v>
                  </c:pt>
                </c:numCache>
              </c:numRef>
            </c:plus>
            <c:minus>
              <c:numRef>
                <c:f>'New Sodium Carbonate'!$M$38:$M$45</c:f>
                <c:numCache>
                  <c:formatCode>General</c:formatCode>
                  <c:ptCount val="8"/>
                  <c:pt idx="0">
                    <c:v>0.108353706675674</c:v>
                  </c:pt>
                  <c:pt idx="1">
                    <c:v>1.12754324528945</c:v>
                  </c:pt>
                  <c:pt idx="2">
                    <c:v>0.471704228921582</c:v>
                  </c:pt>
                  <c:pt idx="3">
                    <c:v>1.084451191018042</c:v>
                  </c:pt>
                  <c:pt idx="4">
                    <c:v>0.371922355385587</c:v>
                  </c:pt>
                  <c:pt idx="5">
                    <c:v>1.77802393642285</c:v>
                  </c:pt>
                  <c:pt idx="6">
                    <c:v>1.00485146279031</c:v>
                  </c:pt>
                  <c:pt idx="7">
                    <c:v>0.246005188304451</c:v>
                  </c:pt>
                </c:numCache>
              </c:numRef>
            </c:minus>
          </c:errBars>
          <c:cat>
            <c:strRef>
              <c:f>'New Sodium Carbonate'!$L$26:$L$33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New Sodium Carbonate'!$M$26:$M$33</c:f>
              <c:numCache>
                <c:formatCode>General</c:formatCode>
                <c:ptCount val="8"/>
                <c:pt idx="0">
                  <c:v>1.384944198499637</c:v>
                </c:pt>
                <c:pt idx="1">
                  <c:v>14.0703686982027</c:v>
                </c:pt>
                <c:pt idx="2">
                  <c:v>25.740585414564</c:v>
                </c:pt>
                <c:pt idx="3">
                  <c:v>20.66466983955693</c:v>
                </c:pt>
                <c:pt idx="4">
                  <c:v>1.486396415175762</c:v>
                </c:pt>
                <c:pt idx="5">
                  <c:v>6.21901681553489</c:v>
                </c:pt>
                <c:pt idx="6">
                  <c:v>29.6899842554986</c:v>
                </c:pt>
                <c:pt idx="7">
                  <c:v>0.744034362967482</c:v>
                </c:pt>
              </c:numCache>
            </c:numRef>
          </c:val>
        </c:ser>
        <c:ser>
          <c:idx val="3"/>
          <c:order val="1"/>
          <c:tx>
            <c:strRef>
              <c:f>'New Sodium Carbonate'!$P$25</c:f>
              <c:strCache>
                <c:ptCount val="1"/>
                <c:pt idx="0">
                  <c:v>35S::PAGR-6</c:v>
                </c:pt>
              </c:strCache>
            </c:strRef>
          </c:tx>
          <c:spPr>
            <a:solidFill>
              <a:srgbClr val="A88AD0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ew Sodium Carbonate'!$P$38:$P$45</c:f>
                <c:numCache>
                  <c:formatCode>General</c:formatCode>
                  <c:ptCount val="8"/>
                  <c:pt idx="0">
                    <c:v>0.126678510823278</c:v>
                  </c:pt>
                  <c:pt idx="1">
                    <c:v>0.560240252403128</c:v>
                  </c:pt>
                  <c:pt idx="2">
                    <c:v>1.843736705072168</c:v>
                  </c:pt>
                  <c:pt idx="3">
                    <c:v>0.961996050875907</c:v>
                  </c:pt>
                  <c:pt idx="4">
                    <c:v>0.589389174339199</c:v>
                  </c:pt>
                  <c:pt idx="5">
                    <c:v>0.276513766465487</c:v>
                  </c:pt>
                  <c:pt idx="6">
                    <c:v>1.957447070927944</c:v>
                  </c:pt>
                  <c:pt idx="7">
                    <c:v>0.060798713053863</c:v>
                  </c:pt>
                </c:numCache>
              </c:numRef>
            </c:plus>
            <c:minus>
              <c:numRef>
                <c:f>'New Sodium Carbonate'!$P$38:$P$45</c:f>
                <c:numCache>
                  <c:formatCode>General</c:formatCode>
                  <c:ptCount val="8"/>
                  <c:pt idx="0">
                    <c:v>0.126678510823278</c:v>
                  </c:pt>
                  <c:pt idx="1">
                    <c:v>0.560240252403128</c:v>
                  </c:pt>
                  <c:pt idx="2">
                    <c:v>1.843736705072168</c:v>
                  </c:pt>
                  <c:pt idx="3">
                    <c:v>0.961996050875907</c:v>
                  </c:pt>
                  <c:pt idx="4">
                    <c:v>0.589389174339199</c:v>
                  </c:pt>
                  <c:pt idx="5">
                    <c:v>0.276513766465487</c:v>
                  </c:pt>
                  <c:pt idx="6">
                    <c:v>1.957447070927944</c:v>
                  </c:pt>
                  <c:pt idx="7">
                    <c:v>0.060798713053863</c:v>
                  </c:pt>
                </c:numCache>
              </c:numRef>
            </c:minus>
          </c:errBars>
          <c:cat>
            <c:strRef>
              <c:f>'New Sodium Carbonate'!$L$26:$L$33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New Sodium Carbonate'!$P$26:$P$33</c:f>
              <c:numCache>
                <c:formatCode>General</c:formatCode>
                <c:ptCount val="8"/>
                <c:pt idx="0">
                  <c:v>0.91144792139775</c:v>
                </c:pt>
                <c:pt idx="1">
                  <c:v>12.53844687367001</c:v>
                </c:pt>
                <c:pt idx="2">
                  <c:v>27.33622082253012</c:v>
                </c:pt>
                <c:pt idx="3">
                  <c:v>19.05749888392385</c:v>
                </c:pt>
                <c:pt idx="4">
                  <c:v>2.103277332449226</c:v>
                </c:pt>
                <c:pt idx="5">
                  <c:v>5.481000080920498</c:v>
                </c:pt>
                <c:pt idx="6">
                  <c:v>32.0206431263049</c:v>
                </c:pt>
                <c:pt idx="7">
                  <c:v>0.551464958803642</c:v>
                </c:pt>
              </c:numCache>
            </c:numRef>
          </c:val>
        </c:ser>
        <c:ser>
          <c:idx val="4"/>
          <c:order val="2"/>
          <c:tx>
            <c:strRef>
              <c:f>'New Sodium Carbonate'!$Q$25</c:f>
              <c:strCache>
                <c:ptCount val="1"/>
                <c:pt idx="0">
                  <c:v>35S::PAGR-7</c:v>
                </c:pt>
              </c:strCache>
            </c:strRef>
          </c:tx>
          <c:spPr>
            <a:solidFill>
              <a:srgbClr val="6EC5E3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ew Sodium Carbonate'!$Q$38:$Q$45</c:f>
                <c:numCache>
                  <c:formatCode>General</c:formatCode>
                  <c:ptCount val="8"/>
                  <c:pt idx="0">
                    <c:v>0.12204353274912</c:v>
                  </c:pt>
                  <c:pt idx="1">
                    <c:v>1.105018152476323</c:v>
                  </c:pt>
                  <c:pt idx="2">
                    <c:v>2.088956045887543</c:v>
                  </c:pt>
                  <c:pt idx="3">
                    <c:v>1.189868813434474</c:v>
                  </c:pt>
                  <c:pt idx="4">
                    <c:v>3.963628845200596</c:v>
                  </c:pt>
                  <c:pt idx="5">
                    <c:v>0.426555049291318</c:v>
                  </c:pt>
                  <c:pt idx="6">
                    <c:v>3.478990679775039</c:v>
                  </c:pt>
                  <c:pt idx="7">
                    <c:v>0.0862570021375902</c:v>
                  </c:pt>
                </c:numCache>
              </c:numRef>
            </c:plus>
            <c:minus>
              <c:numRef>
                <c:f>'New Sodium Carbonate'!$Q$38:$Q$45</c:f>
                <c:numCache>
                  <c:formatCode>General</c:formatCode>
                  <c:ptCount val="8"/>
                  <c:pt idx="0">
                    <c:v>0.12204353274912</c:v>
                  </c:pt>
                  <c:pt idx="1">
                    <c:v>1.105018152476323</c:v>
                  </c:pt>
                  <c:pt idx="2">
                    <c:v>2.088956045887543</c:v>
                  </c:pt>
                  <c:pt idx="3">
                    <c:v>1.189868813434474</c:v>
                  </c:pt>
                  <c:pt idx="4">
                    <c:v>3.963628845200596</c:v>
                  </c:pt>
                  <c:pt idx="5">
                    <c:v>0.426555049291318</c:v>
                  </c:pt>
                  <c:pt idx="6">
                    <c:v>3.478990679775039</c:v>
                  </c:pt>
                  <c:pt idx="7">
                    <c:v>0.0862570021375902</c:v>
                  </c:pt>
                </c:numCache>
              </c:numRef>
            </c:minus>
          </c:errBars>
          <c:cat>
            <c:strRef>
              <c:f>'New Sodium Carbonate'!$L$26:$L$33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New Sodium Carbonate'!$Q$26:$Q$33</c:f>
              <c:numCache>
                <c:formatCode>General</c:formatCode>
                <c:ptCount val="8"/>
                <c:pt idx="0">
                  <c:v>0.798446333713671</c:v>
                </c:pt>
                <c:pt idx="1">
                  <c:v>12.21230444938736</c:v>
                </c:pt>
                <c:pt idx="2">
                  <c:v>27.62894420086388</c:v>
                </c:pt>
                <c:pt idx="3">
                  <c:v>17.99513798527235</c:v>
                </c:pt>
                <c:pt idx="4">
                  <c:v>3.908818139741382</c:v>
                </c:pt>
                <c:pt idx="5">
                  <c:v>5.721449696702011</c:v>
                </c:pt>
                <c:pt idx="6">
                  <c:v>31.20458134358675</c:v>
                </c:pt>
                <c:pt idx="7">
                  <c:v>0.5303178507325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659928"/>
        <c:axId val="2092662984"/>
      </c:barChart>
      <c:catAx>
        <c:axId val="2092659928"/>
        <c:scaling>
          <c:orientation val="minMax"/>
        </c:scaling>
        <c:delete val="0"/>
        <c:axPos val="b"/>
        <c:majorTickMark val="out"/>
        <c:minorTickMark val="none"/>
        <c:tickLblPos val="nextTo"/>
        <c:crossAx val="2092662984"/>
        <c:crosses val="autoZero"/>
        <c:auto val="1"/>
        <c:lblAlgn val="ctr"/>
        <c:lblOffset val="100"/>
        <c:noMultiLvlLbl val="0"/>
      </c:catAx>
      <c:valAx>
        <c:axId val="2092662984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20926599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4K KOH'!$N$44</c:f>
              <c:strCache>
                <c:ptCount val="1"/>
                <c:pt idx="0">
                  <c:v>Col</c:v>
                </c:pt>
              </c:strCache>
            </c:strRef>
          </c:tx>
          <c:spPr>
            <a:solidFill>
              <a:srgbClr val="6EA0E6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4K KOH'!$J$46:$J$53</c:f>
                <c:numCache>
                  <c:formatCode>General</c:formatCode>
                  <c:ptCount val="8"/>
                  <c:pt idx="0">
                    <c:v>0.264998604498648</c:v>
                  </c:pt>
                  <c:pt idx="1">
                    <c:v>0.760644256455618</c:v>
                  </c:pt>
                  <c:pt idx="2">
                    <c:v>1.394254122774048</c:v>
                  </c:pt>
                  <c:pt idx="3">
                    <c:v>0.363543751247064</c:v>
                  </c:pt>
                  <c:pt idx="4">
                    <c:v>2.172777642897382</c:v>
                  </c:pt>
                  <c:pt idx="5">
                    <c:v>1.505815857072773</c:v>
                  </c:pt>
                  <c:pt idx="6">
                    <c:v>1.12940087453652</c:v>
                  </c:pt>
                  <c:pt idx="7">
                    <c:v>0.355049490183314</c:v>
                  </c:pt>
                </c:numCache>
              </c:numRef>
            </c:plus>
            <c:minus>
              <c:numRef>
                <c:f>'4K KOH'!$J$46:$J$53</c:f>
                <c:numCache>
                  <c:formatCode>General</c:formatCode>
                  <c:ptCount val="8"/>
                  <c:pt idx="0">
                    <c:v>0.264998604498648</c:v>
                  </c:pt>
                  <c:pt idx="1">
                    <c:v>0.760644256455618</c:v>
                  </c:pt>
                  <c:pt idx="2">
                    <c:v>1.394254122774048</c:v>
                  </c:pt>
                  <c:pt idx="3">
                    <c:v>0.363543751247064</c:v>
                  </c:pt>
                  <c:pt idx="4">
                    <c:v>2.172777642897382</c:v>
                  </c:pt>
                  <c:pt idx="5">
                    <c:v>1.505815857072773</c:v>
                  </c:pt>
                  <c:pt idx="6">
                    <c:v>1.12940087453652</c:v>
                  </c:pt>
                  <c:pt idx="7">
                    <c:v>0.355049490183314</c:v>
                  </c:pt>
                </c:numCache>
              </c:numRef>
            </c:minus>
          </c:errBars>
          <c:cat>
            <c:strRef>
              <c:f>'4K KOH'!$M$45:$M$52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4K KOH'!$N$45:$N$52</c:f>
              <c:numCache>
                <c:formatCode>General</c:formatCode>
                <c:ptCount val="8"/>
                <c:pt idx="0">
                  <c:v>3.363104131810686</c:v>
                </c:pt>
                <c:pt idx="1">
                  <c:v>3.7418248044105</c:v>
                </c:pt>
                <c:pt idx="2">
                  <c:v>11.13250881219683</c:v>
                </c:pt>
                <c:pt idx="3">
                  <c:v>14.57327572808146</c:v>
                </c:pt>
                <c:pt idx="4">
                  <c:v>28.7419687619104</c:v>
                </c:pt>
                <c:pt idx="5">
                  <c:v>22.69394967875382</c:v>
                </c:pt>
                <c:pt idx="6">
                  <c:v>11.89235434315888</c:v>
                </c:pt>
                <c:pt idx="7">
                  <c:v>3.861013739677438</c:v>
                </c:pt>
              </c:numCache>
            </c:numRef>
          </c:val>
        </c:ser>
        <c:ser>
          <c:idx val="1"/>
          <c:order val="1"/>
          <c:tx>
            <c:strRef>
              <c:f>'4K KOH'!$O$44</c:f>
              <c:strCache>
                <c:ptCount val="1"/>
                <c:pt idx="0">
                  <c:v>35S::PAGR-6</c:v>
                </c:pt>
              </c:strCache>
            </c:strRef>
          </c:tx>
          <c:spPr>
            <a:solidFill>
              <a:srgbClr val="A88AD0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4K KOH'!$J$58:$J$65</c:f>
                <c:numCache>
                  <c:formatCode>General</c:formatCode>
                  <c:ptCount val="8"/>
                  <c:pt idx="0">
                    <c:v>0.259549422575283</c:v>
                  </c:pt>
                  <c:pt idx="1">
                    <c:v>0.392863935268144</c:v>
                  </c:pt>
                  <c:pt idx="2">
                    <c:v>0.827049186549326</c:v>
                  </c:pt>
                  <c:pt idx="3">
                    <c:v>0.20629737095048</c:v>
                  </c:pt>
                  <c:pt idx="4">
                    <c:v>1.244687382166067</c:v>
                  </c:pt>
                  <c:pt idx="5">
                    <c:v>1.160651407970748</c:v>
                  </c:pt>
                  <c:pt idx="6">
                    <c:v>0.799545035641208</c:v>
                  </c:pt>
                  <c:pt idx="7">
                    <c:v>0.236102854592029</c:v>
                  </c:pt>
                </c:numCache>
              </c:numRef>
            </c:plus>
            <c:minus>
              <c:numRef>
                <c:f>'4K KOH'!$J$58:$J$65</c:f>
                <c:numCache>
                  <c:formatCode>General</c:formatCode>
                  <c:ptCount val="8"/>
                  <c:pt idx="0">
                    <c:v>0.259549422575283</c:v>
                  </c:pt>
                  <c:pt idx="1">
                    <c:v>0.392863935268144</c:v>
                  </c:pt>
                  <c:pt idx="2">
                    <c:v>0.827049186549326</c:v>
                  </c:pt>
                  <c:pt idx="3">
                    <c:v>0.20629737095048</c:v>
                  </c:pt>
                  <c:pt idx="4">
                    <c:v>1.244687382166067</c:v>
                  </c:pt>
                  <c:pt idx="5">
                    <c:v>1.160651407970748</c:v>
                  </c:pt>
                  <c:pt idx="6">
                    <c:v>0.799545035641208</c:v>
                  </c:pt>
                  <c:pt idx="7">
                    <c:v>0.236102854592029</c:v>
                  </c:pt>
                </c:numCache>
              </c:numRef>
            </c:minus>
          </c:errBars>
          <c:cat>
            <c:strRef>
              <c:f>'4K KOH'!$M$45:$M$52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4K KOH'!$O$45:$O$52</c:f>
              <c:numCache>
                <c:formatCode>General</c:formatCode>
                <c:ptCount val="8"/>
                <c:pt idx="0">
                  <c:v>2.792711351115306</c:v>
                </c:pt>
                <c:pt idx="1">
                  <c:v>3.752947725217647</c:v>
                </c:pt>
                <c:pt idx="2">
                  <c:v>10.74281969313298</c:v>
                </c:pt>
                <c:pt idx="3">
                  <c:v>14.64322486450388</c:v>
                </c:pt>
                <c:pt idx="4">
                  <c:v>29.14313399992978</c:v>
                </c:pt>
                <c:pt idx="5">
                  <c:v>24.62472625759985</c:v>
                </c:pt>
                <c:pt idx="6">
                  <c:v>11.13742675347519</c:v>
                </c:pt>
                <c:pt idx="7">
                  <c:v>3.163009355025356</c:v>
                </c:pt>
              </c:numCache>
            </c:numRef>
          </c:val>
        </c:ser>
        <c:ser>
          <c:idx val="2"/>
          <c:order val="2"/>
          <c:tx>
            <c:strRef>
              <c:f>'4K KOH'!$P$44</c:f>
              <c:strCache>
                <c:ptCount val="1"/>
                <c:pt idx="0">
                  <c:v>35S::PAGR-7</c:v>
                </c:pt>
              </c:strCache>
            </c:strRef>
          </c:tx>
          <c:spPr>
            <a:solidFill>
              <a:srgbClr val="6EC5E3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4K KOH'!$J$70:$J$77</c:f>
                <c:numCache>
                  <c:formatCode>General</c:formatCode>
                  <c:ptCount val="8"/>
                  <c:pt idx="0">
                    <c:v>0.555845689333782</c:v>
                  </c:pt>
                  <c:pt idx="1">
                    <c:v>0.779499719574579</c:v>
                  </c:pt>
                  <c:pt idx="2">
                    <c:v>1.497537839017166</c:v>
                  </c:pt>
                  <c:pt idx="3">
                    <c:v>2.330999433170513</c:v>
                  </c:pt>
                  <c:pt idx="4">
                    <c:v>12.44328283999248</c:v>
                  </c:pt>
                  <c:pt idx="5">
                    <c:v>4.670962411206799</c:v>
                  </c:pt>
                  <c:pt idx="6">
                    <c:v>2.31163904928808</c:v>
                  </c:pt>
                  <c:pt idx="7">
                    <c:v>0.777928444091104</c:v>
                  </c:pt>
                </c:numCache>
              </c:numRef>
            </c:plus>
            <c:minus>
              <c:numRef>
                <c:f>'4K KOH'!$J$70:$J$77</c:f>
                <c:numCache>
                  <c:formatCode>General</c:formatCode>
                  <c:ptCount val="8"/>
                  <c:pt idx="0">
                    <c:v>0.555845689333782</c:v>
                  </c:pt>
                  <c:pt idx="1">
                    <c:v>0.779499719574579</c:v>
                  </c:pt>
                  <c:pt idx="2">
                    <c:v>1.497537839017166</c:v>
                  </c:pt>
                  <c:pt idx="3">
                    <c:v>2.330999433170513</c:v>
                  </c:pt>
                  <c:pt idx="4">
                    <c:v>12.44328283999248</c:v>
                  </c:pt>
                  <c:pt idx="5">
                    <c:v>4.670962411206799</c:v>
                  </c:pt>
                  <c:pt idx="6">
                    <c:v>2.31163904928808</c:v>
                  </c:pt>
                  <c:pt idx="7">
                    <c:v>0.777928444091104</c:v>
                  </c:pt>
                </c:numCache>
              </c:numRef>
            </c:minus>
          </c:errBars>
          <c:cat>
            <c:strRef>
              <c:f>'4K KOH'!$M$45:$M$52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'4K KOH'!$P$45:$P$52</c:f>
              <c:numCache>
                <c:formatCode>General</c:formatCode>
                <c:ptCount val="8"/>
                <c:pt idx="0">
                  <c:v>2.630889011587112</c:v>
                </c:pt>
                <c:pt idx="1">
                  <c:v>2.766945878975911</c:v>
                </c:pt>
                <c:pt idx="2">
                  <c:v>9.58712121477722</c:v>
                </c:pt>
                <c:pt idx="3">
                  <c:v>12.9145507849268</c:v>
                </c:pt>
                <c:pt idx="4">
                  <c:v>36.19275573475884</c:v>
                </c:pt>
                <c:pt idx="5">
                  <c:v>23.04304157939142</c:v>
                </c:pt>
                <c:pt idx="6">
                  <c:v>9.987963931632173</c:v>
                </c:pt>
                <c:pt idx="7">
                  <c:v>2.876731863950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694744"/>
        <c:axId val="2092697800"/>
      </c:barChart>
      <c:catAx>
        <c:axId val="2092694744"/>
        <c:scaling>
          <c:orientation val="minMax"/>
        </c:scaling>
        <c:delete val="0"/>
        <c:axPos val="b"/>
        <c:majorTickMark val="out"/>
        <c:minorTickMark val="none"/>
        <c:tickLblPos val="nextTo"/>
        <c:crossAx val="2092697800"/>
        <c:crosses val="autoZero"/>
        <c:auto val="1"/>
        <c:lblAlgn val="ctr"/>
        <c:lblOffset val="100"/>
        <c:noMultiLvlLbl val="0"/>
      </c:catAx>
      <c:valAx>
        <c:axId val="2092697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26947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ewPellet!$N$42</c:f>
              <c:strCache>
                <c:ptCount val="1"/>
                <c:pt idx="0">
                  <c:v>Wild Type</c:v>
                </c:pt>
              </c:strCache>
            </c:strRef>
          </c:tx>
          <c:spPr>
            <a:solidFill>
              <a:srgbClr val="6EA0E6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ewPellet!$N$55:$N$62</c:f>
                <c:numCache>
                  <c:formatCode>General</c:formatCode>
                  <c:ptCount val="8"/>
                  <c:pt idx="0">
                    <c:v>0.130011731877518</c:v>
                  </c:pt>
                  <c:pt idx="1">
                    <c:v>0.723456684582274</c:v>
                  </c:pt>
                  <c:pt idx="2">
                    <c:v>1.058395841616042</c:v>
                  </c:pt>
                  <c:pt idx="3">
                    <c:v>1.036048539421533</c:v>
                  </c:pt>
                  <c:pt idx="4">
                    <c:v>4.303023430893402</c:v>
                  </c:pt>
                  <c:pt idx="5">
                    <c:v>0.387601270066093</c:v>
                  </c:pt>
                  <c:pt idx="6">
                    <c:v>1.306264905642977</c:v>
                  </c:pt>
                  <c:pt idx="7">
                    <c:v>0.0586350835729444</c:v>
                  </c:pt>
                </c:numCache>
              </c:numRef>
            </c:plus>
            <c:minus>
              <c:numRef>
                <c:f>NewPellet!$N$55:$N$62</c:f>
                <c:numCache>
                  <c:formatCode>General</c:formatCode>
                  <c:ptCount val="8"/>
                  <c:pt idx="0">
                    <c:v>0.130011731877518</c:v>
                  </c:pt>
                  <c:pt idx="1">
                    <c:v>0.723456684582274</c:v>
                  </c:pt>
                  <c:pt idx="2">
                    <c:v>1.058395841616042</c:v>
                  </c:pt>
                  <c:pt idx="3">
                    <c:v>1.036048539421533</c:v>
                  </c:pt>
                  <c:pt idx="4">
                    <c:v>4.303023430893402</c:v>
                  </c:pt>
                  <c:pt idx="5">
                    <c:v>0.387601270066093</c:v>
                  </c:pt>
                  <c:pt idx="6">
                    <c:v>1.306264905642977</c:v>
                  </c:pt>
                  <c:pt idx="7">
                    <c:v>0.0586350835729444</c:v>
                  </c:pt>
                </c:numCache>
              </c:numRef>
            </c:minus>
          </c:errBars>
          <c:cat>
            <c:strRef>
              <c:f>NewPellet!$M$43:$M$5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NewPellet!$N$43:$N$50</c:f>
              <c:numCache>
                <c:formatCode>General</c:formatCode>
                <c:ptCount val="8"/>
                <c:pt idx="0">
                  <c:v>0.87522189002549</c:v>
                </c:pt>
                <c:pt idx="1">
                  <c:v>4.89238266352701</c:v>
                </c:pt>
                <c:pt idx="2">
                  <c:v>7.908923146973041</c:v>
                </c:pt>
                <c:pt idx="3">
                  <c:v>9.17510634493857</c:v>
                </c:pt>
                <c:pt idx="4">
                  <c:v>57.17217668476451</c:v>
                </c:pt>
                <c:pt idx="5">
                  <c:v>10.59865079282933</c:v>
                </c:pt>
                <c:pt idx="6">
                  <c:v>8.900304152456687</c:v>
                </c:pt>
                <c:pt idx="7">
                  <c:v>0.477234324485363</c:v>
                </c:pt>
              </c:numCache>
            </c:numRef>
          </c:val>
        </c:ser>
        <c:ser>
          <c:idx val="3"/>
          <c:order val="1"/>
          <c:tx>
            <c:strRef>
              <c:f>NewPellet!$Q$42</c:f>
              <c:strCache>
                <c:ptCount val="1"/>
                <c:pt idx="0">
                  <c:v>35S::PAGR-6</c:v>
                </c:pt>
              </c:strCache>
            </c:strRef>
          </c:tx>
          <c:spPr>
            <a:solidFill>
              <a:srgbClr val="A88AD0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ewPellet!$Q$55:$Q$62</c:f>
                <c:numCache>
                  <c:formatCode>General</c:formatCode>
                  <c:ptCount val="8"/>
                  <c:pt idx="0">
                    <c:v>0.0713361192170374</c:v>
                  </c:pt>
                  <c:pt idx="1">
                    <c:v>0.441580433779374</c:v>
                  </c:pt>
                  <c:pt idx="2">
                    <c:v>0.606757463007111</c:v>
                  </c:pt>
                  <c:pt idx="3">
                    <c:v>0.41709983449138</c:v>
                  </c:pt>
                  <c:pt idx="4">
                    <c:v>1.669907790666489</c:v>
                  </c:pt>
                  <c:pt idx="5">
                    <c:v>0.468639396457786</c:v>
                  </c:pt>
                  <c:pt idx="6">
                    <c:v>0.725717159145884</c:v>
                  </c:pt>
                  <c:pt idx="7">
                    <c:v>0.106133920616785</c:v>
                  </c:pt>
                </c:numCache>
              </c:numRef>
            </c:plus>
            <c:minus>
              <c:numRef>
                <c:f>NewPellet!$Q$55:$Q$62</c:f>
                <c:numCache>
                  <c:formatCode>General</c:formatCode>
                  <c:ptCount val="8"/>
                  <c:pt idx="0">
                    <c:v>0.0713361192170374</c:v>
                  </c:pt>
                  <c:pt idx="1">
                    <c:v>0.441580433779374</c:v>
                  </c:pt>
                  <c:pt idx="2">
                    <c:v>0.606757463007111</c:v>
                  </c:pt>
                  <c:pt idx="3">
                    <c:v>0.41709983449138</c:v>
                  </c:pt>
                  <c:pt idx="4">
                    <c:v>1.669907790666489</c:v>
                  </c:pt>
                  <c:pt idx="5">
                    <c:v>0.468639396457786</c:v>
                  </c:pt>
                  <c:pt idx="6">
                    <c:v>0.725717159145884</c:v>
                  </c:pt>
                  <c:pt idx="7">
                    <c:v>0.106133920616785</c:v>
                  </c:pt>
                </c:numCache>
              </c:numRef>
            </c:minus>
          </c:errBars>
          <c:cat>
            <c:strRef>
              <c:f>NewPellet!$M$43:$M$5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NewPellet!$Q$43:$Q$50</c:f>
              <c:numCache>
                <c:formatCode>General</c:formatCode>
                <c:ptCount val="8"/>
                <c:pt idx="0">
                  <c:v>0.566752015432921</c:v>
                </c:pt>
                <c:pt idx="1">
                  <c:v>3.417955803316981</c:v>
                </c:pt>
                <c:pt idx="2">
                  <c:v>6.012845040069437</c:v>
                </c:pt>
                <c:pt idx="3">
                  <c:v>8.571715265683703</c:v>
                </c:pt>
                <c:pt idx="4">
                  <c:v>61.60408728635352</c:v>
                </c:pt>
                <c:pt idx="5">
                  <c:v>12.90423704452044</c:v>
                </c:pt>
                <c:pt idx="6">
                  <c:v>6.587094373975016</c:v>
                </c:pt>
                <c:pt idx="7">
                  <c:v>0.335313170647974</c:v>
                </c:pt>
              </c:numCache>
            </c:numRef>
          </c:val>
        </c:ser>
        <c:ser>
          <c:idx val="4"/>
          <c:order val="2"/>
          <c:tx>
            <c:strRef>
              <c:f>NewPellet!$R$42</c:f>
              <c:strCache>
                <c:ptCount val="1"/>
                <c:pt idx="0">
                  <c:v>35S::PAGR-7</c:v>
                </c:pt>
              </c:strCache>
            </c:strRef>
          </c:tx>
          <c:spPr>
            <a:solidFill>
              <a:srgbClr val="6EC5E3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ewPellet!$R$55:$R$62</c:f>
                <c:numCache>
                  <c:formatCode>General</c:formatCode>
                  <c:ptCount val="8"/>
                  <c:pt idx="0">
                    <c:v>0.149611396046171</c:v>
                  </c:pt>
                  <c:pt idx="1">
                    <c:v>1.131479170989233</c:v>
                  </c:pt>
                  <c:pt idx="2">
                    <c:v>2.149994648786021</c:v>
                  </c:pt>
                  <c:pt idx="3">
                    <c:v>2.170425395535263</c:v>
                  </c:pt>
                  <c:pt idx="4">
                    <c:v>9.839391343322978</c:v>
                  </c:pt>
                  <c:pt idx="5">
                    <c:v>2.245531068476198</c:v>
                  </c:pt>
                  <c:pt idx="6">
                    <c:v>2.184540226100482</c:v>
                  </c:pt>
                  <c:pt idx="7">
                    <c:v>0.0649819725776037</c:v>
                  </c:pt>
                </c:numCache>
              </c:numRef>
            </c:plus>
            <c:minus>
              <c:numRef>
                <c:f>NewPellet!$R$55:$R$62</c:f>
                <c:numCache>
                  <c:formatCode>General</c:formatCode>
                  <c:ptCount val="8"/>
                  <c:pt idx="0">
                    <c:v>0.149611396046171</c:v>
                  </c:pt>
                  <c:pt idx="1">
                    <c:v>1.131479170989233</c:v>
                  </c:pt>
                  <c:pt idx="2">
                    <c:v>2.149994648786021</c:v>
                  </c:pt>
                  <c:pt idx="3">
                    <c:v>2.170425395535263</c:v>
                  </c:pt>
                  <c:pt idx="4">
                    <c:v>9.839391343322978</c:v>
                  </c:pt>
                  <c:pt idx="5">
                    <c:v>2.245531068476198</c:v>
                  </c:pt>
                  <c:pt idx="6">
                    <c:v>2.184540226100482</c:v>
                  </c:pt>
                  <c:pt idx="7">
                    <c:v>0.0649819725776037</c:v>
                  </c:pt>
                </c:numCache>
              </c:numRef>
            </c:minus>
          </c:errBars>
          <c:cat>
            <c:strRef>
              <c:f>NewPellet!$M$43:$M$50</c:f>
              <c:strCache>
                <c:ptCount val="8"/>
                <c:pt idx="0">
                  <c:v>Fuc</c:v>
                </c:pt>
                <c:pt idx="1">
                  <c:v>Rha</c:v>
                </c:pt>
                <c:pt idx="2">
                  <c:v>Ara</c:v>
                </c:pt>
                <c:pt idx="3">
                  <c:v>Gal</c:v>
                </c:pt>
                <c:pt idx="4">
                  <c:v>Glc</c:v>
                </c:pt>
                <c:pt idx="5">
                  <c:v>Xyl/Man</c:v>
                </c:pt>
                <c:pt idx="6">
                  <c:v>GalA</c:v>
                </c:pt>
                <c:pt idx="7">
                  <c:v>GlcA</c:v>
                </c:pt>
              </c:strCache>
            </c:strRef>
          </c:cat>
          <c:val>
            <c:numRef>
              <c:f>NewPellet!$R$43:$R$50</c:f>
              <c:numCache>
                <c:formatCode>General</c:formatCode>
                <c:ptCount val="8"/>
                <c:pt idx="0">
                  <c:v>0.585625809883111</c:v>
                </c:pt>
                <c:pt idx="1">
                  <c:v>3.839403755821761</c:v>
                </c:pt>
                <c:pt idx="2">
                  <c:v>7.066261856092709</c:v>
                </c:pt>
                <c:pt idx="3">
                  <c:v>8.494209987003858</c:v>
                </c:pt>
                <c:pt idx="4">
                  <c:v>61.45525458228231</c:v>
                </c:pt>
                <c:pt idx="5">
                  <c:v>11.14026471713203</c:v>
                </c:pt>
                <c:pt idx="6">
                  <c:v>7.092954366448977</c:v>
                </c:pt>
                <c:pt idx="7">
                  <c:v>0.3260249253352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2728664"/>
        <c:axId val="2092731720"/>
      </c:barChart>
      <c:catAx>
        <c:axId val="2092728664"/>
        <c:scaling>
          <c:orientation val="minMax"/>
        </c:scaling>
        <c:delete val="0"/>
        <c:axPos val="b"/>
        <c:majorTickMark val="out"/>
        <c:minorTickMark val="none"/>
        <c:tickLblPos val="nextTo"/>
        <c:crossAx val="2092731720"/>
        <c:crosses val="autoZero"/>
        <c:auto val="1"/>
        <c:lblAlgn val="ctr"/>
        <c:lblOffset val="100"/>
        <c:noMultiLvlLbl val="0"/>
      </c:catAx>
      <c:valAx>
        <c:axId val="2092731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27286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F20453-7EBD-B84B-BE6E-CF8F9A7D3EF7}" type="datetimeFigureOut">
              <a:rPr lang="en-US" smtClean="0"/>
              <a:t>3/23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DA13F-EDC1-0649-94BE-EDBBAAF47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766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87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76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270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5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32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1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037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02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5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25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294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B6AF3-2EEA-9945-848D-3BF0935DB7BF}" type="datetimeFigureOut">
              <a:rPr lang="en-US" smtClean="0"/>
              <a:t>3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01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2023347"/>
              </p:ext>
            </p:extLst>
          </p:nvPr>
        </p:nvGraphicFramePr>
        <p:xfrm>
          <a:off x="692151" y="2429109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92151" y="2220050"/>
            <a:ext cx="664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DTA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441039" y="2220048"/>
            <a:ext cx="16474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odium Carbonate</a:t>
            </a:r>
          </a:p>
          <a:p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97839" y="4333578"/>
            <a:ext cx="87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4M KOH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41039" y="4347478"/>
            <a:ext cx="874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ellet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3156307" y="5145363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164644" y="2920278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429846" y="5128431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413964" y="2920278"/>
            <a:ext cx="56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mol</a:t>
            </a:r>
            <a:r>
              <a:rPr lang="en-US" sz="1200" dirty="0" smtClean="0"/>
              <a:t>%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1668407" y="3132187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1592207" y="3132187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7208796"/>
              </p:ext>
            </p:extLst>
          </p:nvPr>
        </p:nvGraphicFramePr>
        <p:xfrm>
          <a:off x="3435351" y="2429109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263981"/>
              </p:ext>
            </p:extLst>
          </p:nvPr>
        </p:nvGraphicFramePr>
        <p:xfrm>
          <a:off x="697839" y="4610575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4014336"/>
              </p:ext>
            </p:extLst>
          </p:nvPr>
        </p:nvGraphicFramePr>
        <p:xfrm>
          <a:off x="3441039" y="4610575"/>
          <a:ext cx="2743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044029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4</TotalTime>
  <Words>16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JBE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omon Stonebloom</dc:creator>
  <cp:lastModifiedBy>Solomon Stonebloom</cp:lastModifiedBy>
  <cp:revision>18</cp:revision>
  <dcterms:created xsi:type="dcterms:W3CDTF">2016-01-11T20:47:51Z</dcterms:created>
  <dcterms:modified xsi:type="dcterms:W3CDTF">2016-03-23T22:59:51Z</dcterms:modified>
</cp:coreProperties>
</file>